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4" autoAdjust="0"/>
    <p:restoredTop sz="94660"/>
  </p:normalViewPr>
  <p:slideViewPr>
    <p:cSldViewPr snapToGrid="0">
      <p:cViewPr varScale="1">
        <p:scale>
          <a:sx n="53" d="100"/>
          <a:sy n="53" d="100"/>
        </p:scale>
        <p:origin x="356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C8A54-0FCE-49DE-B67E-C44063444B28}" type="datetimeFigureOut">
              <a:rPr lang="en-US" smtClean="0"/>
              <a:t>2021-02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E47AA-D938-4F19-9EBF-F6DAC87F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334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C8A54-0FCE-49DE-B67E-C44063444B28}" type="datetimeFigureOut">
              <a:rPr lang="en-US" smtClean="0"/>
              <a:t>2021-02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E47AA-D938-4F19-9EBF-F6DAC87F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145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C8A54-0FCE-49DE-B67E-C44063444B28}" type="datetimeFigureOut">
              <a:rPr lang="en-US" smtClean="0"/>
              <a:t>2021-02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E47AA-D938-4F19-9EBF-F6DAC87F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671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C8A54-0FCE-49DE-B67E-C44063444B28}" type="datetimeFigureOut">
              <a:rPr lang="en-US" smtClean="0"/>
              <a:t>2021-02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E47AA-D938-4F19-9EBF-F6DAC87F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934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C8A54-0FCE-49DE-B67E-C44063444B28}" type="datetimeFigureOut">
              <a:rPr lang="en-US" smtClean="0"/>
              <a:t>2021-02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E47AA-D938-4F19-9EBF-F6DAC87F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728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C8A54-0FCE-49DE-B67E-C44063444B28}" type="datetimeFigureOut">
              <a:rPr lang="en-US" smtClean="0"/>
              <a:t>2021-02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E47AA-D938-4F19-9EBF-F6DAC87F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85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C8A54-0FCE-49DE-B67E-C44063444B28}" type="datetimeFigureOut">
              <a:rPr lang="en-US" smtClean="0"/>
              <a:t>2021-02-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E47AA-D938-4F19-9EBF-F6DAC87F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700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C8A54-0FCE-49DE-B67E-C44063444B28}" type="datetimeFigureOut">
              <a:rPr lang="en-US" smtClean="0"/>
              <a:t>2021-02-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E47AA-D938-4F19-9EBF-F6DAC87F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088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C8A54-0FCE-49DE-B67E-C44063444B28}" type="datetimeFigureOut">
              <a:rPr lang="en-US" smtClean="0"/>
              <a:t>2021-02-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E47AA-D938-4F19-9EBF-F6DAC87F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022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C8A54-0FCE-49DE-B67E-C44063444B28}" type="datetimeFigureOut">
              <a:rPr lang="en-US" smtClean="0"/>
              <a:t>2021-02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E47AA-D938-4F19-9EBF-F6DAC87F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689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C8A54-0FCE-49DE-B67E-C44063444B28}" type="datetimeFigureOut">
              <a:rPr lang="en-US" smtClean="0"/>
              <a:t>2021-02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E47AA-D938-4F19-9EBF-F6DAC87F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257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5C8A54-0FCE-49DE-B67E-C44063444B28}" type="datetimeFigureOut">
              <a:rPr lang="en-US" smtClean="0"/>
              <a:t>2021-02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E47AA-D938-4F19-9EBF-F6DAC87F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794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4981" t="6253" r="1124" b="12409"/>
          <a:stretch/>
        </p:blipFill>
        <p:spPr>
          <a:xfrm>
            <a:off x="568822" y="1065008"/>
            <a:ext cx="5444703" cy="353926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7F5E3D6-B01A-42EE-BD28-871D2D00D1DC}"/>
              </a:ext>
            </a:extLst>
          </p:cNvPr>
          <p:cNvSpPr txBox="1"/>
          <p:nvPr/>
        </p:nvSpPr>
        <p:spPr>
          <a:xfrm rot="16200000">
            <a:off x="-712147" y="2333567"/>
            <a:ext cx="2196179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edicted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(10E9 cells/L)</a:t>
            </a:r>
            <a:endParaRPr lang="en-S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03062" y="480233"/>
            <a:ext cx="36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pic>
        <p:nvPicPr>
          <p:cNvPr id="1026" name="Picture 2" descr="The SGPlot Procedure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27" t="6745" r="1300" b="13961"/>
          <a:stretch/>
        </p:blipFill>
        <p:spPr bwMode="auto">
          <a:xfrm>
            <a:off x="6536746" y="1065008"/>
            <a:ext cx="5527612" cy="35414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07F5E3D6-B01A-42EE-BD28-871D2D00D1DC}"/>
              </a:ext>
            </a:extLst>
          </p:cNvPr>
          <p:cNvSpPr txBox="1"/>
          <p:nvPr/>
        </p:nvSpPr>
        <p:spPr>
          <a:xfrm rot="16200000">
            <a:off x="5283520" y="2573030"/>
            <a:ext cx="1983235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edicted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(10E9 cells/L)</a:t>
            </a:r>
            <a:endParaRPr lang="en-S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1329822" y="4604274"/>
            <a:ext cx="3995986" cy="584775"/>
            <a:chOff x="1329822" y="4604274"/>
            <a:chExt cx="3995986" cy="584775"/>
          </a:xfrm>
        </p:grpSpPr>
        <p:sp>
          <p:nvSpPr>
            <p:cNvPr id="18" name="TextBox 17"/>
            <p:cNvSpPr txBox="1"/>
            <p:nvPr/>
          </p:nvSpPr>
          <p:spPr>
            <a:xfrm>
              <a:off x="1329822" y="4604274"/>
              <a:ext cx="399598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                          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ge (years)</a:t>
              </a: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seline Autoantibodies     multiple      single 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54014" y="4978437"/>
              <a:ext cx="128337" cy="108356"/>
            </a:xfrm>
            <a:prstGeom prst="rect">
              <a:avLst/>
            </a:prstGeom>
            <a:solidFill>
              <a:schemeClr val="accent5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03939" y="4978437"/>
              <a:ext cx="128337" cy="108356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7419196" y="4604274"/>
            <a:ext cx="3995986" cy="584775"/>
            <a:chOff x="7419196" y="4604274"/>
            <a:chExt cx="3995986" cy="584775"/>
          </a:xfrm>
        </p:grpSpPr>
        <p:sp>
          <p:nvSpPr>
            <p:cNvPr id="21" name="TextBox 20"/>
            <p:cNvSpPr txBox="1"/>
            <p:nvPr/>
          </p:nvSpPr>
          <p:spPr>
            <a:xfrm>
              <a:off x="7419196" y="4604274"/>
              <a:ext cx="399598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                          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ge (years)</a:t>
              </a: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seline Autoantibodies     multiple      single 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9643388" y="4978437"/>
              <a:ext cx="128337" cy="108356"/>
            </a:xfrm>
            <a:prstGeom prst="rect">
              <a:avLst/>
            </a:prstGeom>
            <a:solidFill>
              <a:schemeClr val="accent5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10593313" y="4978437"/>
              <a:ext cx="128337" cy="108356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307211" y="145774"/>
            <a:ext cx="28070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1.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1222981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16263" y="150607"/>
            <a:ext cx="11380352" cy="6666884"/>
            <a:chOff x="116263" y="150607"/>
            <a:chExt cx="11380352" cy="6666884"/>
          </a:xfrm>
        </p:grpSpPr>
        <p:pic>
          <p:nvPicPr>
            <p:cNvPr id="2050" name="Picture 2" descr="The SGPlot Procedure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23" t="6223" r="1583" b="13071"/>
            <a:stretch/>
          </p:blipFill>
          <p:spPr bwMode="auto">
            <a:xfrm>
              <a:off x="656216" y="376518"/>
              <a:ext cx="4989210" cy="2724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161365" y="150607"/>
              <a:ext cx="3657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B</a:t>
              </a:r>
              <a:endParaRPr lang="en-US" b="1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7F5E3D6-B01A-42EE-BD28-871D2D00D1DC}"/>
                </a:ext>
              </a:extLst>
            </p:cNvPr>
            <p:cNvSpPr txBox="1"/>
            <p:nvPr/>
          </p:nvSpPr>
          <p:spPr>
            <a:xfrm rot="16200000">
              <a:off x="-841660" y="1475427"/>
              <a:ext cx="2439066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edicted Red Blood Cells    (10E9 cells/L)</a:t>
              </a:r>
              <a:endParaRPr lang="en-S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1" name="Picture 3" descr="The SGPlot Procedure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97" t="6824" r="1125" b="17177"/>
            <a:stretch/>
          </p:blipFill>
          <p:spPr bwMode="auto">
            <a:xfrm>
              <a:off x="6473433" y="376518"/>
              <a:ext cx="5023182" cy="27249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7F5E3D6-B01A-42EE-BD28-871D2D00D1DC}"/>
                </a:ext>
              </a:extLst>
            </p:cNvPr>
            <p:cNvSpPr txBox="1"/>
            <p:nvPr/>
          </p:nvSpPr>
          <p:spPr>
            <a:xfrm rot="16200000">
              <a:off x="4728113" y="1663223"/>
              <a:ext cx="299062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edicted Hemoglobin (g/L)</a:t>
              </a:r>
              <a:endParaRPr lang="en-S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2" name="Picture 4" descr="The SGPlot Procedure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16" t="6954" r="1229" b="13516"/>
            <a:stretch/>
          </p:blipFill>
          <p:spPr bwMode="auto">
            <a:xfrm>
              <a:off x="695941" y="3287556"/>
              <a:ext cx="4990369" cy="2945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3" name="Picture 5" descr="The SGPlot Procedure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69" t="6719" r="1053" b="11869"/>
            <a:stretch/>
          </p:blipFill>
          <p:spPr bwMode="auto">
            <a:xfrm>
              <a:off x="6466453" y="3287556"/>
              <a:ext cx="5023182" cy="30996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7F5E3D6-B01A-42EE-BD28-871D2D00D1DC}"/>
                </a:ext>
              </a:extLst>
            </p:cNvPr>
            <p:cNvSpPr txBox="1"/>
            <p:nvPr/>
          </p:nvSpPr>
          <p:spPr>
            <a:xfrm rot="16200000">
              <a:off x="5218722" y="4496851"/>
              <a:ext cx="218768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edicted MCV (f/L)</a:t>
              </a:r>
              <a:endParaRPr lang="en-S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7F5E3D6-B01A-42EE-BD28-871D2D00D1DC}"/>
                </a:ext>
              </a:extLst>
            </p:cNvPr>
            <p:cNvSpPr txBox="1"/>
            <p:nvPr/>
          </p:nvSpPr>
          <p:spPr>
            <a:xfrm rot="16200000">
              <a:off x="-551790" y="4722994"/>
              <a:ext cx="218768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edicted MCH (f/L)</a:t>
              </a:r>
              <a:endParaRPr lang="en-S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276813" y="6126437"/>
              <a:ext cx="399598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                          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ge (years)</a:t>
              </a: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seline Autoantibodies     multiple      single 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3501005" y="6500600"/>
              <a:ext cx="128337" cy="108356"/>
            </a:xfrm>
            <a:prstGeom prst="rect">
              <a:avLst/>
            </a:prstGeom>
            <a:solidFill>
              <a:schemeClr val="accent5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Rectangle 30"/>
            <p:cNvSpPr/>
            <p:nvPr/>
          </p:nvSpPr>
          <p:spPr>
            <a:xfrm>
              <a:off x="4450930" y="6500600"/>
              <a:ext cx="128337" cy="108356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7193908" y="6232716"/>
              <a:ext cx="399598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                          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ge (years)</a:t>
              </a: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seline Autoantibodies     multiple      single 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9418100" y="6606879"/>
              <a:ext cx="128337" cy="108356"/>
            </a:xfrm>
            <a:prstGeom prst="rect">
              <a:avLst/>
            </a:prstGeom>
            <a:solidFill>
              <a:schemeClr val="accent5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Rectangle 33"/>
            <p:cNvSpPr/>
            <p:nvPr/>
          </p:nvSpPr>
          <p:spPr>
            <a:xfrm>
              <a:off x="10368025" y="6606879"/>
              <a:ext cx="128337" cy="108356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6882621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3015736" y="579862"/>
            <a:ext cx="5949844" cy="6072942"/>
            <a:chOff x="3015736" y="579862"/>
            <a:chExt cx="5949844" cy="607294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6BABA80-0A18-4C27-9B7B-580C0658F50A}"/>
                </a:ext>
              </a:extLst>
            </p:cNvPr>
            <p:cNvPicPr/>
            <p:nvPr/>
          </p:nvPicPr>
          <p:blipFill rotWithShape="1">
            <a:blip r:embed="rId2"/>
            <a:srcRect l="1282" t="2064" r="1721" b="1688"/>
            <a:stretch/>
          </p:blipFill>
          <p:spPr>
            <a:xfrm>
              <a:off x="3200400" y="579862"/>
              <a:ext cx="5765180" cy="5720577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4659DD5-7286-4D2E-9E57-0B68E5DD0964}"/>
                </a:ext>
              </a:extLst>
            </p:cNvPr>
            <p:cNvSpPr txBox="1"/>
            <p:nvPr/>
          </p:nvSpPr>
          <p:spPr>
            <a:xfrm rot="16200000">
              <a:off x="2663235" y="2930715"/>
              <a:ext cx="1074333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MCH (pg)</a:t>
              </a:r>
              <a:endParaRPr lang="en-SE" dirty="0"/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5103580" y="5729474"/>
              <a:ext cx="2516420" cy="923330"/>
              <a:chOff x="5103580" y="5729474"/>
              <a:chExt cx="2516420" cy="923330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DF619E26-3D15-45BA-9BCB-C7798BCC2AA7}"/>
                  </a:ext>
                </a:extLst>
              </p:cNvPr>
              <p:cNvSpPr txBox="1"/>
              <p:nvPr/>
            </p:nvSpPr>
            <p:spPr>
              <a:xfrm>
                <a:off x="5103580" y="5729474"/>
                <a:ext cx="2516420" cy="92333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HbA1c (</a:t>
                </a:r>
                <a:r>
                  <a:rPr lang="en-US" dirty="0" err="1"/>
                  <a:t>mmol</a:t>
                </a:r>
                <a:r>
                  <a:rPr lang="en-US" dirty="0"/>
                  <a:t>/</a:t>
                </a:r>
                <a:r>
                  <a:rPr lang="en-US" dirty="0" err="1"/>
                  <a:t>mol</a:t>
                </a:r>
                <a:r>
                  <a:rPr lang="en-US" dirty="0"/>
                  <a:t>)</a:t>
                </a:r>
              </a:p>
              <a:p>
                <a:r>
                  <a:rPr lang="en-US" dirty="0"/>
                  <a:t>IAA first </a:t>
                </a:r>
              </a:p>
              <a:p>
                <a:r>
                  <a:rPr lang="en-US" dirty="0"/>
                  <a:t>GADA first </a:t>
                </a:r>
                <a:endParaRPr lang="en-SE" dirty="0"/>
              </a:p>
            </p:txBody>
          </p:sp>
          <p:sp>
            <p:nvSpPr>
              <p:cNvPr id="7" name="Oval 6">
                <a:extLst>
                  <a:ext uri="{FF2B5EF4-FFF2-40B4-BE49-F238E27FC236}">
                    <a16:creationId xmlns:a16="http://schemas.microsoft.com/office/drawing/2014/main" id="{B80D405E-1BA1-4C9B-89CD-40D2EDF554C5}"/>
                  </a:ext>
                </a:extLst>
              </p:cNvPr>
              <p:cNvSpPr/>
              <p:nvPr/>
            </p:nvSpPr>
            <p:spPr>
              <a:xfrm>
                <a:off x="6068292" y="6123709"/>
                <a:ext cx="147781" cy="138545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E"/>
              </a:p>
            </p:txBody>
          </p:sp>
          <p:sp>
            <p:nvSpPr>
              <p:cNvPr id="8" name="Oval 7">
                <a:extLst>
                  <a:ext uri="{FF2B5EF4-FFF2-40B4-BE49-F238E27FC236}">
                    <a16:creationId xmlns:a16="http://schemas.microsoft.com/office/drawing/2014/main" id="{B6B43824-F8B6-4A4E-B48D-9CCCCE6D9E0A}"/>
                  </a:ext>
                </a:extLst>
              </p:cNvPr>
              <p:cNvSpPr/>
              <p:nvPr/>
            </p:nvSpPr>
            <p:spPr>
              <a:xfrm>
                <a:off x="6287899" y="6400800"/>
                <a:ext cx="147781" cy="138545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E"/>
              </a:p>
            </p:txBody>
          </p:sp>
        </p:grpSp>
      </p:grpSp>
      <p:sp>
        <p:nvSpPr>
          <p:cNvPr id="2" name="TextBox 1"/>
          <p:cNvSpPr txBox="1"/>
          <p:nvPr/>
        </p:nvSpPr>
        <p:spPr>
          <a:xfrm>
            <a:off x="625642" y="579862"/>
            <a:ext cx="14518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91919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012274" y="618836"/>
            <a:ext cx="6011654" cy="6033968"/>
            <a:chOff x="3012274" y="618836"/>
            <a:chExt cx="6011654" cy="603396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D6847D9-6DA3-46BA-83D2-0908EFBBA3BF}"/>
                </a:ext>
              </a:extLst>
            </p:cNvPr>
            <p:cNvPicPr/>
            <p:nvPr/>
          </p:nvPicPr>
          <p:blipFill rotWithShape="1">
            <a:blip r:embed="rId2"/>
            <a:srcRect l="2467" t="2720" r="739" b="2331"/>
            <a:stretch/>
          </p:blipFill>
          <p:spPr>
            <a:xfrm>
              <a:off x="3270828" y="618836"/>
              <a:ext cx="5753100" cy="5643418"/>
            </a:xfrm>
            <a:prstGeom prst="rect">
              <a:avLst/>
            </a:prstGeom>
          </p:spPr>
        </p:pic>
        <p:grpSp>
          <p:nvGrpSpPr>
            <p:cNvPr id="2" name="Group 1"/>
            <p:cNvGrpSpPr/>
            <p:nvPr/>
          </p:nvGrpSpPr>
          <p:grpSpPr>
            <a:xfrm>
              <a:off x="5103580" y="5729474"/>
              <a:ext cx="2516420" cy="923330"/>
              <a:chOff x="5103580" y="5729474"/>
              <a:chExt cx="2516420" cy="923330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D8BD9048-8E07-42FF-BDAA-08CFAF6276E6}"/>
                  </a:ext>
                </a:extLst>
              </p:cNvPr>
              <p:cNvSpPr txBox="1"/>
              <p:nvPr/>
            </p:nvSpPr>
            <p:spPr>
              <a:xfrm>
                <a:off x="5103580" y="5729474"/>
                <a:ext cx="2516420" cy="92333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HbA1c (</a:t>
                </a:r>
                <a:r>
                  <a:rPr lang="en-US" dirty="0" err="1"/>
                  <a:t>mmol</a:t>
                </a:r>
                <a:r>
                  <a:rPr lang="en-US" dirty="0"/>
                  <a:t>/</a:t>
                </a:r>
                <a:r>
                  <a:rPr lang="en-US" dirty="0" err="1"/>
                  <a:t>mol</a:t>
                </a:r>
                <a:r>
                  <a:rPr lang="en-US" dirty="0"/>
                  <a:t>)</a:t>
                </a:r>
              </a:p>
              <a:p>
                <a:r>
                  <a:rPr lang="en-US" dirty="0"/>
                  <a:t>IAA first </a:t>
                </a:r>
              </a:p>
              <a:p>
                <a:r>
                  <a:rPr lang="en-US" dirty="0"/>
                  <a:t>GADA first </a:t>
                </a:r>
                <a:endParaRPr lang="en-SE" dirty="0"/>
              </a:p>
            </p:txBody>
          </p:sp>
          <p:sp>
            <p:nvSpPr>
              <p:cNvPr id="6" name="Oval 5">
                <a:extLst>
                  <a:ext uri="{FF2B5EF4-FFF2-40B4-BE49-F238E27FC236}">
                    <a16:creationId xmlns:a16="http://schemas.microsoft.com/office/drawing/2014/main" id="{B80D405E-1BA1-4C9B-89CD-40D2EDF554C5}"/>
                  </a:ext>
                </a:extLst>
              </p:cNvPr>
              <p:cNvSpPr/>
              <p:nvPr/>
            </p:nvSpPr>
            <p:spPr>
              <a:xfrm>
                <a:off x="6068292" y="6123709"/>
                <a:ext cx="147781" cy="138545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E"/>
              </a:p>
            </p:txBody>
          </p:sp>
          <p:sp>
            <p:nvSpPr>
              <p:cNvPr id="7" name="Oval 6">
                <a:extLst>
                  <a:ext uri="{FF2B5EF4-FFF2-40B4-BE49-F238E27FC236}">
                    <a16:creationId xmlns:a16="http://schemas.microsoft.com/office/drawing/2014/main" id="{B6B43824-F8B6-4A4E-B48D-9CCCCE6D9E0A}"/>
                  </a:ext>
                </a:extLst>
              </p:cNvPr>
              <p:cNvSpPr/>
              <p:nvPr/>
            </p:nvSpPr>
            <p:spPr>
              <a:xfrm>
                <a:off x="6287899" y="6400800"/>
                <a:ext cx="147781" cy="138545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E"/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EE0A765-5B98-4CE4-90F8-8CBAEBCAC872}"/>
                </a:ext>
              </a:extLst>
            </p:cNvPr>
            <p:cNvSpPr txBox="1"/>
            <p:nvPr/>
          </p:nvSpPr>
          <p:spPr>
            <a:xfrm rot="16200000">
              <a:off x="2697444" y="2845158"/>
              <a:ext cx="99899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MCV (</a:t>
              </a:r>
              <a:r>
                <a:rPr lang="en-US" dirty="0" err="1" smtClean="0"/>
                <a:t>fL</a:t>
              </a:r>
              <a:r>
                <a:rPr lang="en-US" dirty="0" smtClean="0"/>
                <a:t>)</a:t>
              </a:r>
              <a:endParaRPr lang="en-SE" dirty="0"/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625642" y="579862"/>
            <a:ext cx="14518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2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6235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10</Words>
  <Application>Microsoft Office PowerPoint</Application>
  <PresentationFormat>Widescreen</PresentationFormat>
  <Paragraphs>2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Lunds universit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lastin Salami</dc:creator>
  <cp:lastModifiedBy>Falastin Salami</cp:lastModifiedBy>
  <cp:revision>2</cp:revision>
  <dcterms:created xsi:type="dcterms:W3CDTF">2021-02-19T13:03:07Z</dcterms:created>
  <dcterms:modified xsi:type="dcterms:W3CDTF">2021-02-19T13:07:59Z</dcterms:modified>
</cp:coreProperties>
</file>